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3600450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1" userDrawn="1">
          <p15:clr>
            <a:srgbClr val="A4A3A4"/>
          </p15:clr>
        </p15:guide>
        <p15:guide id="2" pos="113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ikorski, Franziska" initials="SF" lastIdx="0" clrIdx="0">
    <p:extLst>
      <p:ext uri="{19B8F6BF-5375-455C-9EA6-DF929625EA0E}">
        <p15:presenceInfo xmlns:p15="http://schemas.microsoft.com/office/powerpoint/2012/main" userId="S-1-5-21-1415759971-1158191895-317929798-6027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7171"/>
    <a:srgbClr val="020044"/>
    <a:srgbClr val="EEFBFA"/>
    <a:srgbClr val="52358E"/>
    <a:srgbClr val="D67A94"/>
    <a:srgbClr val="4BC4B1"/>
    <a:srgbClr val="46C1AD"/>
    <a:srgbClr val="51C6B2"/>
    <a:srgbClr val="E8F9F7"/>
    <a:srgbClr val="E9FA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24" autoAdjust="0"/>
    <p:restoredTop sz="94660"/>
  </p:normalViewPr>
  <p:slideViewPr>
    <p:cSldViewPr snapToGrid="0">
      <p:cViewPr varScale="1">
        <p:scale>
          <a:sx n="88" d="100"/>
          <a:sy n="88" d="100"/>
        </p:scale>
        <p:origin x="2568" y="84"/>
      </p:cViewPr>
      <p:guideLst>
        <p:guide orient="horz" pos="131"/>
        <p:guide pos="11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0034" y="883861"/>
            <a:ext cx="3060383" cy="1880235"/>
          </a:xfrm>
        </p:spPr>
        <p:txBody>
          <a:bodyPr anchor="b"/>
          <a:lstStyle>
            <a:lvl1pPr algn="ctr">
              <a:defRPr sz="236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0056" y="2836605"/>
            <a:ext cx="2700338" cy="1303913"/>
          </a:xfrm>
        </p:spPr>
        <p:txBody>
          <a:bodyPr/>
          <a:lstStyle>
            <a:lvl1pPr marL="0" indent="0" algn="ctr">
              <a:buNone/>
              <a:defRPr sz="945"/>
            </a:lvl1pPr>
            <a:lvl2pPr marL="180045" indent="0" algn="ctr">
              <a:buNone/>
              <a:defRPr sz="788"/>
            </a:lvl2pPr>
            <a:lvl3pPr marL="360091" indent="0" algn="ctr">
              <a:buNone/>
              <a:defRPr sz="709"/>
            </a:lvl3pPr>
            <a:lvl4pPr marL="540136" indent="0" algn="ctr">
              <a:buNone/>
              <a:defRPr sz="630"/>
            </a:lvl4pPr>
            <a:lvl5pPr marL="720181" indent="0" algn="ctr">
              <a:buNone/>
              <a:defRPr sz="630"/>
            </a:lvl5pPr>
            <a:lvl6pPr marL="900227" indent="0" algn="ctr">
              <a:buNone/>
              <a:defRPr sz="630"/>
            </a:lvl6pPr>
            <a:lvl7pPr marL="1080272" indent="0" algn="ctr">
              <a:buNone/>
              <a:defRPr sz="630"/>
            </a:lvl7pPr>
            <a:lvl8pPr marL="1260318" indent="0" algn="ctr">
              <a:buNone/>
              <a:defRPr sz="630"/>
            </a:lvl8pPr>
            <a:lvl9pPr marL="1440363" indent="0" algn="ctr">
              <a:buNone/>
              <a:defRPr sz="63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2902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5587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572" y="287536"/>
            <a:ext cx="776347" cy="4576822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531" y="287536"/>
            <a:ext cx="2284035" cy="4576822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3224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6676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56" y="1346420"/>
            <a:ext cx="3105388" cy="2246530"/>
          </a:xfrm>
        </p:spPr>
        <p:txBody>
          <a:bodyPr anchor="b"/>
          <a:lstStyle>
            <a:lvl1pPr>
              <a:defRPr sz="236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56" y="3614203"/>
            <a:ext cx="3105388" cy="1181397"/>
          </a:xfrm>
        </p:spPr>
        <p:txBody>
          <a:bodyPr/>
          <a:lstStyle>
            <a:lvl1pPr marL="0" indent="0">
              <a:buNone/>
              <a:defRPr sz="945">
                <a:solidFill>
                  <a:schemeClr val="tx1"/>
                </a:solidFill>
              </a:defRPr>
            </a:lvl1pPr>
            <a:lvl2pPr marL="18004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2pPr>
            <a:lvl3pPr marL="360091" indent="0">
              <a:buNone/>
              <a:defRPr sz="709">
                <a:solidFill>
                  <a:schemeClr val="tx1">
                    <a:tint val="75000"/>
                  </a:schemeClr>
                </a:solidFill>
              </a:defRPr>
            </a:lvl3pPr>
            <a:lvl4pPr marL="540136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4pPr>
            <a:lvl5pPr marL="720181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5pPr>
            <a:lvl6pPr marL="900227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6pPr>
            <a:lvl7pPr marL="1080272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7pPr>
            <a:lvl8pPr marL="1260318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8pPr>
            <a:lvl9pPr marL="1440363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2571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531" y="1437680"/>
            <a:ext cx="1530191" cy="34266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728" y="1437680"/>
            <a:ext cx="1530191" cy="34266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6549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8000" y="287537"/>
            <a:ext cx="3105388" cy="104388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8000" y="1323916"/>
            <a:ext cx="1523159" cy="648831"/>
          </a:xfrm>
        </p:spPr>
        <p:txBody>
          <a:bodyPr anchor="b"/>
          <a:lstStyle>
            <a:lvl1pPr marL="0" indent="0">
              <a:buNone/>
              <a:defRPr sz="945" b="1"/>
            </a:lvl1pPr>
            <a:lvl2pPr marL="180045" indent="0">
              <a:buNone/>
              <a:defRPr sz="788" b="1"/>
            </a:lvl2pPr>
            <a:lvl3pPr marL="360091" indent="0">
              <a:buNone/>
              <a:defRPr sz="709" b="1"/>
            </a:lvl3pPr>
            <a:lvl4pPr marL="540136" indent="0">
              <a:buNone/>
              <a:defRPr sz="630" b="1"/>
            </a:lvl4pPr>
            <a:lvl5pPr marL="720181" indent="0">
              <a:buNone/>
              <a:defRPr sz="630" b="1"/>
            </a:lvl5pPr>
            <a:lvl6pPr marL="900227" indent="0">
              <a:buNone/>
              <a:defRPr sz="630" b="1"/>
            </a:lvl6pPr>
            <a:lvl7pPr marL="1080272" indent="0">
              <a:buNone/>
              <a:defRPr sz="630" b="1"/>
            </a:lvl7pPr>
            <a:lvl8pPr marL="1260318" indent="0">
              <a:buNone/>
              <a:defRPr sz="630" b="1"/>
            </a:lvl8pPr>
            <a:lvl9pPr marL="1440363" indent="0">
              <a:buNone/>
              <a:defRPr sz="63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8000" y="1972747"/>
            <a:ext cx="1523159" cy="290161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728" y="1323916"/>
            <a:ext cx="1530660" cy="648831"/>
          </a:xfrm>
        </p:spPr>
        <p:txBody>
          <a:bodyPr anchor="b"/>
          <a:lstStyle>
            <a:lvl1pPr marL="0" indent="0">
              <a:buNone/>
              <a:defRPr sz="945" b="1"/>
            </a:lvl1pPr>
            <a:lvl2pPr marL="180045" indent="0">
              <a:buNone/>
              <a:defRPr sz="788" b="1"/>
            </a:lvl2pPr>
            <a:lvl3pPr marL="360091" indent="0">
              <a:buNone/>
              <a:defRPr sz="709" b="1"/>
            </a:lvl3pPr>
            <a:lvl4pPr marL="540136" indent="0">
              <a:buNone/>
              <a:defRPr sz="630" b="1"/>
            </a:lvl4pPr>
            <a:lvl5pPr marL="720181" indent="0">
              <a:buNone/>
              <a:defRPr sz="630" b="1"/>
            </a:lvl5pPr>
            <a:lvl6pPr marL="900227" indent="0">
              <a:buNone/>
              <a:defRPr sz="630" b="1"/>
            </a:lvl6pPr>
            <a:lvl7pPr marL="1080272" indent="0">
              <a:buNone/>
              <a:defRPr sz="630" b="1"/>
            </a:lvl7pPr>
            <a:lvl8pPr marL="1260318" indent="0">
              <a:buNone/>
              <a:defRPr sz="630" b="1"/>
            </a:lvl8pPr>
            <a:lvl9pPr marL="1440363" indent="0">
              <a:buNone/>
              <a:defRPr sz="63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728" y="1972747"/>
            <a:ext cx="1530660" cy="290161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4641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8530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5694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8000" y="360045"/>
            <a:ext cx="1161239" cy="1260158"/>
          </a:xfrm>
        </p:spPr>
        <p:txBody>
          <a:bodyPr anchor="b"/>
          <a:lstStyle>
            <a:lvl1pPr>
              <a:defRPr sz="12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660" y="777598"/>
            <a:ext cx="1822728" cy="3837980"/>
          </a:xfrm>
        </p:spPr>
        <p:txBody>
          <a:bodyPr/>
          <a:lstStyle>
            <a:lvl1pPr>
              <a:defRPr sz="1260"/>
            </a:lvl1pPr>
            <a:lvl2pPr>
              <a:defRPr sz="1103"/>
            </a:lvl2pPr>
            <a:lvl3pPr>
              <a:defRPr sz="945"/>
            </a:lvl3pPr>
            <a:lvl4pPr>
              <a:defRPr sz="788"/>
            </a:lvl4pPr>
            <a:lvl5pPr>
              <a:defRPr sz="788"/>
            </a:lvl5pPr>
            <a:lvl6pPr>
              <a:defRPr sz="788"/>
            </a:lvl6pPr>
            <a:lvl7pPr>
              <a:defRPr sz="788"/>
            </a:lvl7pPr>
            <a:lvl8pPr>
              <a:defRPr sz="788"/>
            </a:lvl8pPr>
            <a:lvl9pPr>
              <a:defRPr sz="788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8000" y="1620202"/>
            <a:ext cx="1161239" cy="3001626"/>
          </a:xfrm>
        </p:spPr>
        <p:txBody>
          <a:bodyPr/>
          <a:lstStyle>
            <a:lvl1pPr marL="0" indent="0">
              <a:buNone/>
              <a:defRPr sz="630"/>
            </a:lvl1pPr>
            <a:lvl2pPr marL="180045" indent="0">
              <a:buNone/>
              <a:defRPr sz="551"/>
            </a:lvl2pPr>
            <a:lvl3pPr marL="360091" indent="0">
              <a:buNone/>
              <a:defRPr sz="473"/>
            </a:lvl3pPr>
            <a:lvl4pPr marL="540136" indent="0">
              <a:buNone/>
              <a:defRPr sz="394"/>
            </a:lvl4pPr>
            <a:lvl5pPr marL="720181" indent="0">
              <a:buNone/>
              <a:defRPr sz="394"/>
            </a:lvl5pPr>
            <a:lvl6pPr marL="900227" indent="0">
              <a:buNone/>
              <a:defRPr sz="394"/>
            </a:lvl6pPr>
            <a:lvl7pPr marL="1080272" indent="0">
              <a:buNone/>
              <a:defRPr sz="394"/>
            </a:lvl7pPr>
            <a:lvl8pPr marL="1260318" indent="0">
              <a:buNone/>
              <a:defRPr sz="394"/>
            </a:lvl8pPr>
            <a:lvl9pPr marL="1440363" indent="0">
              <a:buNone/>
              <a:defRPr sz="394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7812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8000" y="360045"/>
            <a:ext cx="1161239" cy="1260158"/>
          </a:xfrm>
        </p:spPr>
        <p:txBody>
          <a:bodyPr anchor="b"/>
          <a:lstStyle>
            <a:lvl1pPr>
              <a:defRPr sz="12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660" y="777598"/>
            <a:ext cx="1822728" cy="3837980"/>
          </a:xfrm>
        </p:spPr>
        <p:txBody>
          <a:bodyPr anchor="t"/>
          <a:lstStyle>
            <a:lvl1pPr marL="0" indent="0">
              <a:buNone/>
              <a:defRPr sz="1260"/>
            </a:lvl1pPr>
            <a:lvl2pPr marL="180045" indent="0">
              <a:buNone/>
              <a:defRPr sz="1103"/>
            </a:lvl2pPr>
            <a:lvl3pPr marL="360091" indent="0">
              <a:buNone/>
              <a:defRPr sz="945"/>
            </a:lvl3pPr>
            <a:lvl4pPr marL="540136" indent="0">
              <a:buNone/>
              <a:defRPr sz="788"/>
            </a:lvl4pPr>
            <a:lvl5pPr marL="720181" indent="0">
              <a:buNone/>
              <a:defRPr sz="788"/>
            </a:lvl5pPr>
            <a:lvl6pPr marL="900227" indent="0">
              <a:buNone/>
              <a:defRPr sz="788"/>
            </a:lvl6pPr>
            <a:lvl7pPr marL="1080272" indent="0">
              <a:buNone/>
              <a:defRPr sz="788"/>
            </a:lvl7pPr>
            <a:lvl8pPr marL="1260318" indent="0">
              <a:buNone/>
              <a:defRPr sz="788"/>
            </a:lvl8pPr>
            <a:lvl9pPr marL="1440363" indent="0">
              <a:buNone/>
              <a:defRPr sz="788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8000" y="1620202"/>
            <a:ext cx="1161239" cy="3001626"/>
          </a:xfrm>
        </p:spPr>
        <p:txBody>
          <a:bodyPr/>
          <a:lstStyle>
            <a:lvl1pPr marL="0" indent="0">
              <a:buNone/>
              <a:defRPr sz="630"/>
            </a:lvl1pPr>
            <a:lvl2pPr marL="180045" indent="0">
              <a:buNone/>
              <a:defRPr sz="551"/>
            </a:lvl2pPr>
            <a:lvl3pPr marL="360091" indent="0">
              <a:buNone/>
              <a:defRPr sz="473"/>
            </a:lvl3pPr>
            <a:lvl4pPr marL="540136" indent="0">
              <a:buNone/>
              <a:defRPr sz="394"/>
            </a:lvl4pPr>
            <a:lvl5pPr marL="720181" indent="0">
              <a:buNone/>
              <a:defRPr sz="394"/>
            </a:lvl5pPr>
            <a:lvl6pPr marL="900227" indent="0">
              <a:buNone/>
              <a:defRPr sz="394"/>
            </a:lvl6pPr>
            <a:lvl7pPr marL="1080272" indent="0">
              <a:buNone/>
              <a:defRPr sz="394"/>
            </a:lvl7pPr>
            <a:lvl8pPr marL="1260318" indent="0">
              <a:buNone/>
              <a:defRPr sz="394"/>
            </a:lvl8pPr>
            <a:lvl9pPr marL="1440363" indent="0">
              <a:buNone/>
              <a:defRPr sz="394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7519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531" y="287537"/>
            <a:ext cx="3105388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531" y="1437680"/>
            <a:ext cx="3105388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531" y="5005627"/>
            <a:ext cx="810101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649" y="5005627"/>
            <a:ext cx="1215152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818" y="5005627"/>
            <a:ext cx="810101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3505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360091" rtl="0" eaLnBrk="1" latinLnBrk="0" hangingPunct="1">
        <a:lnSpc>
          <a:spcPct val="90000"/>
        </a:lnSpc>
        <a:spcBef>
          <a:spcPct val="0"/>
        </a:spcBef>
        <a:buNone/>
        <a:defRPr sz="17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0023" indent="-90023" algn="l" defTabSz="360091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103" kern="1200">
          <a:solidFill>
            <a:schemeClr val="tx1"/>
          </a:solidFill>
          <a:latin typeface="+mn-lt"/>
          <a:ea typeface="+mn-ea"/>
          <a:cs typeface="+mn-cs"/>
        </a:defRPr>
      </a:lvl1pPr>
      <a:lvl2pPr marL="270068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50113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88" kern="1200">
          <a:solidFill>
            <a:schemeClr val="tx1"/>
          </a:solidFill>
          <a:latin typeface="+mn-lt"/>
          <a:ea typeface="+mn-ea"/>
          <a:cs typeface="+mn-cs"/>
        </a:defRPr>
      </a:lvl3pPr>
      <a:lvl4pPr marL="630159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4pPr>
      <a:lvl5pPr marL="810204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5pPr>
      <a:lvl6pPr marL="990249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6pPr>
      <a:lvl7pPr marL="1170295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7pPr>
      <a:lvl8pPr marL="1350340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8pPr>
      <a:lvl9pPr marL="1530386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1pPr>
      <a:lvl2pPr marL="180045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2pPr>
      <a:lvl3pPr marL="360091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3pPr>
      <a:lvl4pPr marL="540136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4pPr>
      <a:lvl5pPr marL="720181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5pPr>
      <a:lvl6pPr marL="900227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6pPr>
      <a:lvl7pPr marL="1080272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7pPr>
      <a:lvl8pPr marL="1260318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8pPr>
      <a:lvl9pPr marL="1440363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extfeld 123"/>
          <p:cNvSpPr txBox="1"/>
          <p:nvPr/>
        </p:nvSpPr>
        <p:spPr>
          <a:xfrm>
            <a:off x="301708" y="225455"/>
            <a:ext cx="3040205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800" b="1" dirty="0" smtClean="0">
                <a:latin typeface="+mj-lt"/>
                <a:cs typeface="Times New Roman" panose="02020603050405020304" pitchFamily="18" charset="0"/>
              </a:rPr>
              <a:t>Multimedia Appendix 5</a:t>
            </a:r>
            <a:r>
              <a:rPr lang="en-GB" sz="800" b="1" i="1" dirty="0" smtClean="0">
                <a:latin typeface="+mj-lt"/>
                <a:cs typeface="Times New Roman" panose="02020603050405020304" pitchFamily="18" charset="0"/>
              </a:rPr>
              <a:t>. </a:t>
            </a:r>
            <a:r>
              <a:rPr lang="en-US" sz="800" dirty="0">
                <a:latin typeface="+mj-lt"/>
                <a:cs typeface="Times New Roman" panose="02020603050405020304" pitchFamily="18" charset="0"/>
              </a:rPr>
              <a:t>Illustration of the emergency advice displayed to participants with elevated suicidal ideation (mobile version</a:t>
            </a:r>
            <a:r>
              <a:rPr lang="en-US" sz="800" dirty="0" smtClean="0">
                <a:latin typeface="+mj-lt"/>
                <a:cs typeface="Times New Roman" panose="02020603050405020304" pitchFamily="18" charset="0"/>
              </a:rPr>
              <a:t>). </a:t>
            </a:r>
            <a:endParaRPr lang="en-GB" sz="800" dirty="0">
              <a:latin typeface="+mj-lt"/>
              <a:cs typeface="Times New Roman" panose="02020603050405020304" pitchFamily="18" charset="0"/>
            </a:endParaRPr>
          </a:p>
        </p:txBody>
      </p:sp>
      <p:grpSp>
        <p:nvGrpSpPr>
          <p:cNvPr id="16" name="Gruppieren 15"/>
          <p:cNvGrpSpPr/>
          <p:nvPr/>
        </p:nvGrpSpPr>
        <p:grpSpPr>
          <a:xfrm>
            <a:off x="809291" y="925040"/>
            <a:ext cx="1446176" cy="2228850"/>
            <a:chOff x="571571" y="3923023"/>
            <a:chExt cx="1446176" cy="2228850"/>
          </a:xfrm>
        </p:grpSpPr>
        <p:grpSp>
          <p:nvGrpSpPr>
            <p:cNvPr id="118" name="Gruppieren 117"/>
            <p:cNvGrpSpPr/>
            <p:nvPr/>
          </p:nvGrpSpPr>
          <p:grpSpPr>
            <a:xfrm>
              <a:off x="571571" y="3923023"/>
              <a:ext cx="1207293" cy="2228850"/>
              <a:chOff x="160811" y="109780"/>
              <a:chExt cx="1207293" cy="2228850"/>
            </a:xfrm>
          </p:grpSpPr>
          <p:pic>
            <p:nvPicPr>
              <p:cNvPr id="119" name="Grafik 11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949" t="4937" r="35899" b="4597"/>
              <a:stretch/>
            </p:blipFill>
            <p:spPr>
              <a:xfrm>
                <a:off x="160811" y="109780"/>
                <a:ext cx="1207293" cy="2228850"/>
              </a:xfrm>
              <a:prstGeom prst="roundRect">
                <a:avLst/>
              </a:prstGeom>
            </p:spPr>
          </p:pic>
          <p:sp>
            <p:nvSpPr>
              <p:cNvPr id="120" name="Textfeld 119"/>
              <p:cNvSpPr txBox="1"/>
              <p:nvPr/>
            </p:nvSpPr>
            <p:spPr>
              <a:xfrm>
                <a:off x="304394" y="495357"/>
                <a:ext cx="1063569" cy="32316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GB" sz="1050" b="1" dirty="0">
                    <a:solidFill>
                      <a:srgbClr val="020044"/>
                    </a:solidFill>
                    <a:latin typeface="Constantia" panose="02030602050306030303" pitchFamily="18" charset="0"/>
                  </a:rPr>
                  <a:t>Thank you for participating! </a:t>
                </a:r>
              </a:p>
            </p:txBody>
          </p:sp>
          <p:sp>
            <p:nvSpPr>
              <p:cNvPr id="121" name="Textfeld 120"/>
              <p:cNvSpPr txBox="1"/>
              <p:nvPr/>
            </p:nvSpPr>
            <p:spPr>
              <a:xfrm>
                <a:off x="304394" y="875923"/>
                <a:ext cx="1000013" cy="46166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600" dirty="0">
                    <a:solidFill>
                      <a:srgbClr val="020044"/>
                    </a:solidFill>
                  </a:rPr>
                  <a:t>By taking part in </a:t>
                </a:r>
                <a:r>
                  <a:rPr lang="en-US" sz="600" b="1" dirty="0">
                    <a:solidFill>
                      <a:srgbClr val="020044"/>
                    </a:solidFill>
                  </a:rPr>
                  <a:t>D I S C O V E R</a:t>
                </a:r>
                <a:r>
                  <a:rPr lang="en-US" sz="600" dirty="0">
                    <a:solidFill>
                      <a:srgbClr val="020044"/>
                    </a:solidFill>
                  </a:rPr>
                  <a:t> you have made an important contribution to mental wellbeing research!</a:t>
                </a:r>
              </a:p>
              <a:p>
                <a:endParaRPr lang="en-US" sz="600" dirty="0">
                  <a:solidFill>
                    <a:srgbClr val="020044"/>
                  </a:solidFill>
                </a:endParaRPr>
              </a:p>
            </p:txBody>
          </p:sp>
          <p:pic>
            <p:nvPicPr>
              <p:cNvPr id="122" name="Grafik 121"/>
              <p:cNvPicPr>
                <a:picLocks noChangeAspect="1"/>
              </p:cNvPicPr>
              <p:nvPr/>
            </p:nvPicPr>
            <p:blipFill rotWithShape="1">
              <a:blip r:embed="rId3"/>
              <a:srcRect l="6555" r="71209" b="92749"/>
              <a:stretch/>
            </p:blipFill>
            <p:spPr>
              <a:xfrm>
                <a:off x="246346" y="287277"/>
                <a:ext cx="739141" cy="163725"/>
              </a:xfrm>
              <a:prstGeom prst="rect">
                <a:avLst/>
              </a:prstGeom>
            </p:spPr>
          </p:pic>
          <p:pic>
            <p:nvPicPr>
              <p:cNvPr id="123" name="Grafik 122"/>
              <p:cNvPicPr>
                <a:picLocks noChangeAspect="1"/>
              </p:cNvPicPr>
              <p:nvPr/>
            </p:nvPicPr>
            <p:blipFill rotWithShape="1">
              <a:blip r:embed="rId3"/>
              <a:srcRect l="76057" t="1637" r="6924" b="94820"/>
              <a:stretch/>
            </p:blipFill>
            <p:spPr>
              <a:xfrm>
                <a:off x="618927" y="2189332"/>
                <a:ext cx="371693" cy="52563"/>
              </a:xfrm>
              <a:prstGeom prst="rect">
                <a:avLst/>
              </a:prstGeom>
            </p:spPr>
          </p:pic>
        </p:grpSp>
        <p:sp>
          <p:nvSpPr>
            <p:cNvPr id="10" name="Abgerundetes Rechteck 9"/>
            <p:cNvSpPr/>
            <p:nvPr/>
          </p:nvSpPr>
          <p:spPr>
            <a:xfrm>
              <a:off x="571571" y="3974123"/>
              <a:ext cx="1207152" cy="2177750"/>
            </a:xfrm>
            <a:prstGeom prst="roundRect">
              <a:avLst/>
            </a:prstGeom>
            <a:solidFill>
              <a:srgbClr val="767171">
                <a:alpha val="38824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hteck 8"/>
            <p:cNvSpPr/>
            <p:nvPr/>
          </p:nvSpPr>
          <p:spPr>
            <a:xfrm>
              <a:off x="656802" y="4202004"/>
              <a:ext cx="1047430" cy="178510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500" dirty="0">
                  <a:solidFill>
                    <a:srgbClr val="020044"/>
                  </a:solidFill>
                </a:rPr>
                <a:t>You have indicated that you 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have had thoughts of death recently.</a:t>
              </a:r>
            </a:p>
            <a:p>
              <a:endParaRPr lang="en-US" sz="500" dirty="0">
                <a:solidFill>
                  <a:srgbClr val="020044"/>
                </a:solidFill>
              </a:endParaRPr>
            </a:p>
            <a:p>
              <a:r>
                <a:rPr lang="en-US" sz="500" dirty="0">
                  <a:solidFill>
                    <a:srgbClr val="020044"/>
                  </a:solidFill>
                </a:rPr>
                <a:t>If you are thinking about taking your own life, please take one of the following steps: 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- Contact the nearest psychiatric   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hospital or the </a:t>
              </a:r>
              <a:r>
                <a:rPr lang="en-US" sz="500" dirty="0" err="1">
                  <a:solidFill>
                    <a:srgbClr val="020044"/>
                  </a:solidFill>
                </a:rPr>
                <a:t>emergenc</a:t>
              </a:r>
              <a:endParaRPr lang="en-US" sz="500" dirty="0">
                <a:solidFill>
                  <a:srgbClr val="020044"/>
                </a:solidFill>
              </a:endParaRPr>
            </a:p>
            <a:p>
              <a:r>
                <a:rPr lang="en-US" sz="500" dirty="0">
                  <a:solidFill>
                    <a:srgbClr val="020044"/>
                  </a:solidFill>
                </a:rPr>
                <a:t>   medical service by </a:t>
              </a:r>
              <a:r>
                <a:rPr lang="en-US" sz="500" dirty="0" err="1">
                  <a:solidFill>
                    <a:srgbClr val="020044"/>
                  </a:solidFill>
                </a:rPr>
                <a:t>dialling</a:t>
              </a:r>
              <a:r>
                <a:rPr lang="en-US" sz="500" dirty="0">
                  <a:solidFill>
                    <a:srgbClr val="020044"/>
                  </a:solidFill>
                </a:rPr>
                <a:t> </a:t>
              </a:r>
              <a:r>
                <a:rPr lang="en-US" sz="500" u="sng" dirty="0">
                  <a:solidFill>
                    <a:srgbClr val="020044"/>
                  </a:solidFill>
                </a:rPr>
                <a:t>112</a:t>
              </a:r>
              <a:r>
                <a:rPr lang="en-US" sz="500" dirty="0">
                  <a:solidFill>
                    <a:srgbClr val="020044"/>
                  </a:solidFill>
                </a:rPr>
                <a:t>. 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- Contact the following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professional counsellors: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General practitioners,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psychiatrists, or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psychotherapists. They are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trained and can discuss further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steps with you. 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- Contact the telephone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counselling service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anonymously 24/7 (phone: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</a:t>
              </a:r>
              <a:r>
                <a:rPr lang="en-US" sz="500" u="sng" dirty="0">
                  <a:solidFill>
                    <a:srgbClr val="020044"/>
                  </a:solidFill>
                </a:rPr>
                <a:t>0800 - 111 0 111</a:t>
              </a:r>
              <a:r>
                <a:rPr lang="en-US" sz="500" dirty="0">
                  <a:solidFill>
                    <a:srgbClr val="020044"/>
                  </a:solidFill>
                </a:rPr>
                <a:t>;</a:t>
              </a:r>
            </a:p>
            <a:p>
              <a:r>
                <a:rPr lang="en-US" sz="500" dirty="0">
                  <a:solidFill>
                    <a:srgbClr val="020044"/>
                  </a:solidFill>
                </a:rPr>
                <a:t>   </a:t>
              </a:r>
              <a:r>
                <a:rPr lang="en-US" sz="500" u="sng" dirty="0">
                  <a:solidFill>
                    <a:srgbClr val="020044"/>
                  </a:solidFill>
                </a:rPr>
                <a:t>www.telefonseelsorge.de</a:t>
              </a:r>
              <a:r>
                <a:rPr lang="en-US" sz="500" dirty="0">
                  <a:solidFill>
                    <a:srgbClr val="020044"/>
                  </a:solidFill>
                </a:rPr>
                <a:t>).</a:t>
              </a: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1469107" y="4163837"/>
              <a:ext cx="548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09733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1</Words>
  <Application>Microsoft Office PowerPoint</Application>
  <PresentationFormat>Benutzerdefiniert</PresentationFormat>
  <Paragraphs>2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nstantia</vt:lpstr>
      <vt:lpstr>Times New Roman</vt:lpstr>
      <vt:lpstr>Office</vt:lpstr>
      <vt:lpstr>PowerPoint-Präsentation</vt:lpstr>
    </vt:vector>
  </TitlesOfParts>
  <Company>UK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adke, Marie Phoebe</dc:creator>
  <cp:lastModifiedBy>Sikorski, Franziska</cp:lastModifiedBy>
  <cp:revision>49</cp:revision>
  <dcterms:created xsi:type="dcterms:W3CDTF">2023-11-23T09:09:03Z</dcterms:created>
  <dcterms:modified xsi:type="dcterms:W3CDTF">2024-04-12T18:26:19Z</dcterms:modified>
</cp:coreProperties>
</file>